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294" r:id="rId5"/>
    <p:sldId id="322" r:id="rId6"/>
    <p:sldId id="32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athan Thomas Sims" initials="JS" lastIdx="11" clrIdx="0">
    <p:extLst>
      <p:ext uri="{19B8F6BF-5375-455C-9EA6-DF929625EA0E}">
        <p15:presenceInfo xmlns:p15="http://schemas.microsoft.com/office/powerpoint/2012/main" userId="S::sims_jonathan_thomas@lilly.com::9689d190-e762-42e8-968f-412125b9f1a8" providerId="AD"/>
      </p:ext>
    </p:extLst>
  </p:cmAuthor>
  <p:cmAuthor id="2" name="Veavi Ching-Yun Chang" initials="VCYC" lastIdx="5" clrIdx="1">
    <p:extLst>
      <p:ext uri="{19B8F6BF-5375-455C-9EA6-DF929625EA0E}">
        <p15:presenceInfo xmlns:p15="http://schemas.microsoft.com/office/powerpoint/2012/main" userId="S::veavi.chang@lilly.com::e75288ca-25fd-4f17-b0c4-f9b6081a4cb8" providerId="AD"/>
      </p:ext>
    </p:extLst>
  </p:cmAuthor>
  <p:cmAuthor id="3" name="Josh Poorbaugh" initials="JP" lastIdx="1" clrIdx="2">
    <p:extLst>
      <p:ext uri="{19B8F6BF-5375-455C-9EA6-DF929625EA0E}">
        <p15:presenceInfo xmlns:p15="http://schemas.microsoft.com/office/powerpoint/2012/main" userId="S::jpoorbaugh@lilly.com::9aef3b01-e181-4ddd-b67e-d1799fa10f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A807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nathan Thomas Sims" userId="9689d190-e762-42e8-968f-412125b9f1a8" providerId="ADAL" clId="{6AF687DF-3483-4003-BFF4-7925A5DA31DD}"/>
    <pc:docChg chg="modSld">
      <pc:chgData name="Jonathan Thomas Sims" userId="9689d190-e762-42e8-968f-412125b9f1a8" providerId="ADAL" clId="{6AF687DF-3483-4003-BFF4-7925A5DA31DD}" dt="2021-11-30T19:31:20.569" v="0" actId="6549"/>
      <pc:docMkLst>
        <pc:docMk/>
      </pc:docMkLst>
      <pc:sldChg chg="modNotesTx">
        <pc:chgData name="Jonathan Thomas Sims" userId="9689d190-e762-42e8-968f-412125b9f1a8" providerId="ADAL" clId="{6AF687DF-3483-4003-BFF4-7925A5DA31DD}" dt="2021-11-30T19:31:20.569" v="0" actId="6549"/>
        <pc:sldMkLst>
          <pc:docMk/>
          <pc:sldMk cId="670234237" sldId="305"/>
        </pc:sldMkLst>
      </pc:sldChg>
    </pc:docChg>
  </pc:docChgLst>
  <pc:docChgLst>
    <pc:chgData name="Jonathan Thomas Sims" userId="9689d190-e762-42e8-968f-412125b9f1a8" providerId="ADAL" clId="{F69C1BAD-18C6-4E0A-B3BA-6B92201BA84F}"/>
    <pc:docChg chg="modSld">
      <pc:chgData name="Jonathan Thomas Sims" userId="9689d190-e762-42e8-968f-412125b9f1a8" providerId="ADAL" clId="{F69C1BAD-18C6-4E0A-B3BA-6B92201BA84F}" dt="2021-10-19T21:43:36.100" v="2" actId="20577"/>
      <pc:docMkLst>
        <pc:docMk/>
      </pc:docMkLst>
      <pc:sldChg chg="modSp mod">
        <pc:chgData name="Jonathan Thomas Sims" userId="9689d190-e762-42e8-968f-412125b9f1a8" providerId="ADAL" clId="{F69C1BAD-18C6-4E0A-B3BA-6B92201BA84F}" dt="2021-10-19T21:43:36.100" v="2" actId="20577"/>
        <pc:sldMkLst>
          <pc:docMk/>
          <pc:sldMk cId="3985169982" sldId="322"/>
        </pc:sldMkLst>
        <pc:graphicFrameChg chg="modGraphic">
          <ac:chgData name="Jonathan Thomas Sims" userId="9689d190-e762-42e8-968f-412125b9f1a8" providerId="ADAL" clId="{F69C1BAD-18C6-4E0A-B3BA-6B92201BA84F}" dt="2021-10-19T21:43:36.100" v="2" actId="20577"/>
          <ac:graphicFrameMkLst>
            <pc:docMk/>
            <pc:sldMk cId="3985169982" sldId="322"/>
            <ac:graphicFrameMk id="7" creationId="{44C51032-6527-4AB0-88E7-E67BB4435CF3}"/>
          </ac:graphicFrameMkLst>
        </pc:graphicFrameChg>
      </pc:sldChg>
    </pc:docChg>
  </pc:docChgLst>
  <pc:docChgLst>
    <pc:chgData name="Jonathan Thomas Sims" userId="9689d190-e762-42e8-968f-412125b9f1a8" providerId="ADAL" clId="{D73BDD92-BCF4-47E6-8BA3-E189814D229F}"/>
    <pc:docChg chg="modSld sldOrd">
      <pc:chgData name="Jonathan Thomas Sims" userId="9689d190-e762-42e8-968f-412125b9f1a8" providerId="ADAL" clId="{D73BDD92-BCF4-47E6-8BA3-E189814D229F}" dt="2022-01-10T17:57:05.819" v="5" actId="20577"/>
      <pc:docMkLst>
        <pc:docMk/>
      </pc:docMkLst>
      <pc:sldChg chg="modSp mod">
        <pc:chgData name="Jonathan Thomas Sims" userId="9689d190-e762-42e8-968f-412125b9f1a8" providerId="ADAL" clId="{D73BDD92-BCF4-47E6-8BA3-E189814D229F}" dt="2022-01-10T17:57:02.544" v="3" actId="20577"/>
        <pc:sldMkLst>
          <pc:docMk/>
          <pc:sldMk cId="2189010205" sldId="294"/>
        </pc:sldMkLst>
        <pc:spChg chg="mod">
          <ac:chgData name="Jonathan Thomas Sims" userId="9689d190-e762-42e8-968f-412125b9f1a8" providerId="ADAL" clId="{D73BDD92-BCF4-47E6-8BA3-E189814D229F}" dt="2022-01-10T17:57:02.544" v="3" actId="20577"/>
          <ac:spMkLst>
            <pc:docMk/>
            <pc:sldMk cId="2189010205" sldId="294"/>
            <ac:spMk id="4" creationId="{CD138B48-B308-4190-81F8-A87F97389C38}"/>
          </ac:spMkLst>
        </pc:spChg>
      </pc:sldChg>
      <pc:sldChg chg="modSp mod ord">
        <pc:chgData name="Jonathan Thomas Sims" userId="9689d190-e762-42e8-968f-412125b9f1a8" providerId="ADAL" clId="{D73BDD92-BCF4-47E6-8BA3-E189814D229F}" dt="2022-01-10T17:57:05.819" v="5" actId="20577"/>
        <pc:sldMkLst>
          <pc:docMk/>
          <pc:sldMk cId="3985169982" sldId="322"/>
        </pc:sldMkLst>
        <pc:spChg chg="mod">
          <ac:chgData name="Jonathan Thomas Sims" userId="9689d190-e762-42e8-968f-412125b9f1a8" providerId="ADAL" clId="{D73BDD92-BCF4-47E6-8BA3-E189814D229F}" dt="2022-01-10T17:57:05.819" v="5" actId="20577"/>
          <ac:spMkLst>
            <pc:docMk/>
            <pc:sldMk cId="3985169982" sldId="322"/>
            <ac:spMk id="3" creationId="{86AEF047-01B6-420D-9027-0F93FA9C02F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547B8A-E5EE-4FDE-AF4D-6439C215CAC3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5B7377-F4C9-4222-9C6B-8E81AA1F0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623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5B7377-F4C9-4222-9C6B-8E81AA1F034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6390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D138B48-B308-4190-81F8-A87F97389C38}"/>
              </a:ext>
            </a:extLst>
          </p:cNvPr>
          <p:cNvSpPr txBox="1"/>
          <p:nvPr/>
        </p:nvSpPr>
        <p:spPr>
          <a:xfrm>
            <a:off x="-11328" y="-14326"/>
            <a:ext cx="6348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/>
                <a:cs typeface="Arial"/>
              </a:rPr>
              <a:t>Baseline Characteristics of COVID-19 patients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xmlns="" id="{CC1CDDE2-B65A-4B07-B2B6-0C51DC0C8A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4828318"/>
              </p:ext>
            </p:extLst>
          </p:nvPr>
        </p:nvGraphicFramePr>
        <p:xfrm>
          <a:off x="-11328" y="355007"/>
          <a:ext cx="12151620" cy="74016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1357">
                  <a:extLst>
                    <a:ext uri="{9D8B030D-6E8A-4147-A177-3AD203B41FA5}">
                      <a16:colId xmlns:a16="http://schemas.microsoft.com/office/drawing/2014/main" xmlns="" val="3603771794"/>
                    </a:ext>
                  </a:extLst>
                </a:gridCol>
                <a:gridCol w="455000">
                  <a:extLst>
                    <a:ext uri="{9D8B030D-6E8A-4147-A177-3AD203B41FA5}">
                      <a16:colId xmlns:a16="http://schemas.microsoft.com/office/drawing/2014/main" xmlns="" val="777343842"/>
                    </a:ext>
                  </a:extLst>
                </a:gridCol>
                <a:gridCol w="318407">
                  <a:extLst>
                    <a:ext uri="{9D8B030D-6E8A-4147-A177-3AD203B41FA5}">
                      <a16:colId xmlns:a16="http://schemas.microsoft.com/office/drawing/2014/main" xmlns="" val="2337754479"/>
                    </a:ext>
                  </a:extLst>
                </a:gridCol>
                <a:gridCol w="346982">
                  <a:extLst>
                    <a:ext uri="{9D8B030D-6E8A-4147-A177-3AD203B41FA5}">
                      <a16:colId xmlns:a16="http://schemas.microsoft.com/office/drawing/2014/main" xmlns="" val="9696852"/>
                    </a:ext>
                  </a:extLst>
                </a:gridCol>
                <a:gridCol w="391886">
                  <a:extLst>
                    <a:ext uri="{9D8B030D-6E8A-4147-A177-3AD203B41FA5}">
                      <a16:colId xmlns:a16="http://schemas.microsoft.com/office/drawing/2014/main" xmlns="" val="126493953"/>
                    </a:ext>
                  </a:extLst>
                </a:gridCol>
                <a:gridCol w="404132">
                  <a:extLst>
                    <a:ext uri="{9D8B030D-6E8A-4147-A177-3AD203B41FA5}">
                      <a16:colId xmlns:a16="http://schemas.microsoft.com/office/drawing/2014/main" xmlns="" val="4059036524"/>
                    </a:ext>
                  </a:extLst>
                </a:gridCol>
                <a:gridCol w="710293">
                  <a:extLst>
                    <a:ext uri="{9D8B030D-6E8A-4147-A177-3AD203B41FA5}">
                      <a16:colId xmlns:a16="http://schemas.microsoft.com/office/drawing/2014/main" xmlns="" val="2671576198"/>
                    </a:ext>
                  </a:extLst>
                </a:gridCol>
                <a:gridCol w="1559378">
                  <a:extLst>
                    <a:ext uri="{9D8B030D-6E8A-4147-A177-3AD203B41FA5}">
                      <a16:colId xmlns:a16="http://schemas.microsoft.com/office/drawing/2014/main" xmlns="" val="3921349488"/>
                    </a:ext>
                  </a:extLst>
                </a:gridCol>
                <a:gridCol w="759279">
                  <a:extLst>
                    <a:ext uri="{9D8B030D-6E8A-4147-A177-3AD203B41FA5}">
                      <a16:colId xmlns:a16="http://schemas.microsoft.com/office/drawing/2014/main" xmlns="" val="3037557534"/>
                    </a:ext>
                  </a:extLst>
                </a:gridCol>
                <a:gridCol w="734785">
                  <a:extLst>
                    <a:ext uri="{9D8B030D-6E8A-4147-A177-3AD203B41FA5}">
                      <a16:colId xmlns:a16="http://schemas.microsoft.com/office/drawing/2014/main" xmlns="" val="1970197163"/>
                    </a:ext>
                  </a:extLst>
                </a:gridCol>
                <a:gridCol w="608240">
                  <a:extLst>
                    <a:ext uri="{9D8B030D-6E8A-4147-A177-3AD203B41FA5}">
                      <a16:colId xmlns:a16="http://schemas.microsoft.com/office/drawing/2014/main" xmlns="" val="1065314924"/>
                    </a:ext>
                  </a:extLst>
                </a:gridCol>
                <a:gridCol w="853143">
                  <a:extLst>
                    <a:ext uri="{9D8B030D-6E8A-4147-A177-3AD203B41FA5}">
                      <a16:colId xmlns:a16="http://schemas.microsoft.com/office/drawing/2014/main" xmlns="" val="8328891"/>
                    </a:ext>
                  </a:extLst>
                </a:gridCol>
                <a:gridCol w="731526">
                  <a:extLst>
                    <a:ext uri="{9D8B030D-6E8A-4147-A177-3AD203B41FA5}">
                      <a16:colId xmlns:a16="http://schemas.microsoft.com/office/drawing/2014/main" xmlns="" val="1622033128"/>
                    </a:ext>
                  </a:extLst>
                </a:gridCol>
                <a:gridCol w="1031984">
                  <a:extLst>
                    <a:ext uri="{9D8B030D-6E8A-4147-A177-3AD203B41FA5}">
                      <a16:colId xmlns:a16="http://schemas.microsoft.com/office/drawing/2014/main" xmlns="" val="1211034815"/>
                    </a:ext>
                  </a:extLst>
                </a:gridCol>
                <a:gridCol w="493940">
                  <a:extLst>
                    <a:ext uri="{9D8B030D-6E8A-4147-A177-3AD203B41FA5}">
                      <a16:colId xmlns:a16="http://schemas.microsoft.com/office/drawing/2014/main" xmlns="" val="1832833959"/>
                    </a:ext>
                  </a:extLst>
                </a:gridCol>
                <a:gridCol w="1118507">
                  <a:extLst>
                    <a:ext uri="{9D8B030D-6E8A-4147-A177-3AD203B41FA5}">
                      <a16:colId xmlns:a16="http://schemas.microsoft.com/office/drawing/2014/main" xmlns="" val="3284237642"/>
                    </a:ext>
                  </a:extLst>
                </a:gridCol>
                <a:gridCol w="1032781">
                  <a:extLst>
                    <a:ext uri="{9D8B030D-6E8A-4147-A177-3AD203B41FA5}">
                      <a16:colId xmlns:a16="http://schemas.microsoft.com/office/drawing/2014/main" xmlns="" val="2852180141"/>
                    </a:ext>
                  </a:extLst>
                </a:gridCol>
              </a:tblGrid>
              <a:tr h="295465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SAMPLE 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 ONSET DA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MISSION DA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ALE WHO ADMI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 ADMIS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DA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 O2 SUPPOR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2 (%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COLLECTION DA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TICOSTEROID TREATMEN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71097742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18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1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A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ametha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04246084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1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cough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A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ametha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20845789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2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chest pain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1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ametha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66283900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213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2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/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uri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ametha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2723513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316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27754148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317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51004712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12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1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uri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3670519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06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ametha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31470261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07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 cough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ask</a:t>
                      </a: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CPA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28945510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66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 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33867492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08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uri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63021150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001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1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36995223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248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46953078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637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60599748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61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 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2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1073462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06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2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8942551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314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c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5398820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564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3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97453867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173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/>
                          <a:cs typeface="Arial"/>
                        </a:rPr>
                        <a:t>Fever, Dyspnea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uri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1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79570834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001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 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11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55706320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19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i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7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75856672"/>
                  </a:ext>
                </a:extLst>
              </a:tr>
              <a:tr h="100081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077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1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ent A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/24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31701702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MA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 loss, asthenia, fev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4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flow oxyge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20657167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 MO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gh, fev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21804345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 J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3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9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ygen by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99121956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U A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 syndrome, dyspne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4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flow oxyge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3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42128229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 FR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dyspnea, anos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20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ygen by ma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16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12844101"/>
                  </a:ext>
                </a:extLst>
              </a:tr>
              <a:tr h="197773"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R EM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1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,  dyspnea, diarrhea, coug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/25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U-Discharge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/8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cal Ventila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/4/20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200000"/>
                        </a:lnSpc>
                      </a:pPr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prednisolone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82" marR="2982" marT="298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838046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9010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6AEF047-01B6-420D-9027-0F93FA9C02F7}"/>
              </a:ext>
            </a:extLst>
          </p:cNvPr>
          <p:cNvSpPr txBox="1"/>
          <p:nvPr/>
        </p:nvSpPr>
        <p:spPr>
          <a:xfrm>
            <a:off x="-11328" y="-14326"/>
            <a:ext cx="7361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.  Recombinant Proteins used in Serology Measurements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44C51032-6527-4AB0-88E7-E67BB4435C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8073154"/>
              </p:ext>
            </p:extLst>
          </p:nvPr>
        </p:nvGraphicFramePr>
        <p:xfrm>
          <a:off x="2571750" y="732102"/>
          <a:ext cx="7048500" cy="2495550"/>
        </p:xfrm>
        <a:graphic>
          <a:graphicData uri="http://schemas.openxmlformats.org/drawingml/2006/table">
            <a:tbl>
              <a:tblPr/>
              <a:tblGrid>
                <a:gridCol w="1409700">
                  <a:extLst>
                    <a:ext uri="{9D8B030D-6E8A-4147-A177-3AD203B41FA5}">
                      <a16:colId xmlns:a16="http://schemas.microsoft.com/office/drawing/2014/main" xmlns="" val="3433657965"/>
                    </a:ext>
                  </a:extLst>
                </a:gridCol>
                <a:gridCol w="2159000">
                  <a:extLst>
                    <a:ext uri="{9D8B030D-6E8A-4147-A177-3AD203B41FA5}">
                      <a16:colId xmlns:a16="http://schemas.microsoft.com/office/drawing/2014/main" xmlns="" val="3409718943"/>
                    </a:ext>
                  </a:extLst>
                </a:gridCol>
                <a:gridCol w="1993900">
                  <a:extLst>
                    <a:ext uri="{9D8B030D-6E8A-4147-A177-3AD203B41FA5}">
                      <a16:colId xmlns:a16="http://schemas.microsoft.com/office/drawing/2014/main" xmlns="" val="3142682012"/>
                    </a:ext>
                  </a:extLst>
                </a:gridCol>
                <a:gridCol w="1485900">
                  <a:extLst>
                    <a:ext uri="{9D8B030D-6E8A-4147-A177-3AD203B41FA5}">
                      <a16:colId xmlns:a16="http://schemas.microsoft.com/office/drawing/2014/main" xmlns="" val="180570595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RS-CoV-2 Sequence Length (AA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g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press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6382368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4 (14-30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iTag, His T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214538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9 (1-419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iTag, His T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604011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4 (319-592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iTag, His T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807849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9 (329-52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iTag, His T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396602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ll Length Spike (ST4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5 (14-1208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 trimerization, AviTag, His T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047503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-F490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 (319-541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5038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-N460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 (319-541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54513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-E484Q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 (319-541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90319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-Q493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3 (319-541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959450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ull Length Spike D614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5 (14-1208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4 trimerization, AviTag, His Ta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18541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E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8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8-615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 Ta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246355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L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96 (1-1296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 Ta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culovirus-Insect Cell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363123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851699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BBA6587-0D9E-439A-A70D-95E5DA76F872}"/>
              </a:ext>
            </a:extLst>
          </p:cNvPr>
          <p:cNvSpPr txBox="1"/>
          <p:nvPr/>
        </p:nvSpPr>
        <p:spPr>
          <a:xfrm>
            <a:off x="-11328" y="-1432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0842A3CE-D4FA-4E16-AA53-C58D82AFE0D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789"/>
          <a:stretch/>
        </p:blipFill>
        <p:spPr bwMode="auto">
          <a:xfrm>
            <a:off x="4617249" y="686605"/>
            <a:ext cx="2373188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xmlns="" id="{AF37DCB9-D16C-4934-A458-3F80F311734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68"/>
          <a:stretch/>
        </p:blipFill>
        <p:spPr bwMode="auto">
          <a:xfrm>
            <a:off x="8495499" y="610405"/>
            <a:ext cx="2631066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CCEC4AB-A663-48D3-9E11-EFC1519309F1}"/>
              </a:ext>
            </a:extLst>
          </p:cNvPr>
          <p:cNvSpPr txBox="1"/>
          <p:nvPr/>
        </p:nvSpPr>
        <p:spPr>
          <a:xfrm>
            <a:off x="248821" y="612534"/>
            <a:ext cx="229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86640D61-21D1-48AE-8628-C80D30F1C851}"/>
              </a:ext>
            </a:extLst>
          </p:cNvPr>
          <p:cNvSpPr txBox="1"/>
          <p:nvPr/>
        </p:nvSpPr>
        <p:spPr>
          <a:xfrm>
            <a:off x="4239676" y="610405"/>
            <a:ext cx="229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DA67E314-0B8F-4273-8F66-E2E9967CBFC7}"/>
              </a:ext>
            </a:extLst>
          </p:cNvPr>
          <p:cNvSpPr txBox="1"/>
          <p:nvPr/>
        </p:nvSpPr>
        <p:spPr>
          <a:xfrm>
            <a:off x="8206731" y="610405"/>
            <a:ext cx="229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F01CA5E-FA86-41BD-8A02-04B97F8947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932" y="979737"/>
            <a:ext cx="2566638" cy="1566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3573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6E75ED295D4740973A245F7F0472DF" ma:contentTypeVersion="4" ma:contentTypeDescription="Create a new document." ma:contentTypeScope="" ma:versionID="c75b677a94861a84ca6a87f656756027">
  <xsd:schema xmlns:xsd="http://www.w3.org/2001/XMLSchema" xmlns:xs="http://www.w3.org/2001/XMLSchema" xmlns:p="http://schemas.microsoft.com/office/2006/metadata/properties" xmlns:ns2="119b4b46-496d-4618-9880-feb55d259d99" targetNamespace="http://schemas.microsoft.com/office/2006/metadata/properties" ma:root="true" ma:fieldsID="2078e20c5fbeffefbd2be91100e44523" ns2:_="">
    <xsd:import namespace="119b4b46-496d-4618-9880-feb55d259d9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19b4b46-496d-4618-9880-feb55d259d9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05CCEF5-5458-4295-B386-5C2C0F004305}">
  <ds:schemaRefs>
    <ds:schemaRef ds:uri="119b4b46-496d-4618-9880-feb55d259d9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10D940F6-C786-49C0-B353-851920B20C3C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119b4b46-496d-4618-9880-feb55d259d99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E100E597-840B-4C95-9F0B-D7A6C1A70E8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758</Words>
  <Application>Microsoft Office PowerPoint</Application>
  <PresentationFormat>Widescreen</PresentationFormat>
  <Paragraphs>54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Jini Mol</cp:lastModifiedBy>
  <cp:revision>2</cp:revision>
  <dcterms:created xsi:type="dcterms:W3CDTF">2021-02-19T11:40:06Z</dcterms:created>
  <dcterms:modified xsi:type="dcterms:W3CDTF">2022-09-03T04:06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6E75ED295D4740973A245F7F0472DF</vt:lpwstr>
  </property>
</Properties>
</file>